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25ED6-83D5-4140-B8C4-BB5F8D4240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2A3A34-5509-497A-88FB-C4AF3EE04F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FD8AF-4425-450F-B4E6-9FCFB228E6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5804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076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5804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521E8-09D0-40C6-AAD4-D5993D8D46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39EFF-144A-48B1-9F5A-CC6A0D6F02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D430F-9F21-46B1-B7BF-20F85F8AB3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25AA5-6242-49AA-9A1A-F506EA72B0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585B1-5C98-4011-9E05-EAB0F7F52A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0760" y="365040"/>
            <a:ext cx="8543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24690-F858-45BB-8AC8-6807B3E292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5A691-EA7A-4E41-81FA-51FF728EF5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45FB2-0A34-40FF-B53B-D0F280FC0E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E032A-CF9A-40E3-8519-AD85428C40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076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81040" y="6356520"/>
            <a:ext cx="3343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99588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01114EA-8C46-4706-8120-FB4209021FCB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9"/>
          <p:cNvSpPr/>
          <p:nvPr/>
        </p:nvSpPr>
        <p:spPr>
          <a:xfrm>
            <a:off x="246240" y="179280"/>
            <a:ext cx="9421560" cy="167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itle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Impairments of </a:t>
            </a:r>
            <a:r>
              <a:rPr b="1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synuclein and Mechanistic Target of Rapamycin in Rotenone-induced SH-SY5Y Cell and Mice Models of Parkinson’s Diseas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 SH-SY5Y cells were seeded as 1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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ells/ml of DMEM containing 10% FBS or 1% FBS or 1% BSA and used for experiments after overnight incubation. Cells were incubated with the absence or presence of different concentrations of ROT (0, 0.5, 1, 2.5, 5 and 1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 for 24 h and assessed for morphological changes, 100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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Each picture is a representative of three independent experiment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"/>
          <p:cNvGrpSpPr/>
          <p:nvPr/>
        </p:nvGrpSpPr>
        <p:grpSpPr>
          <a:xfrm>
            <a:off x="0" y="2106720"/>
            <a:ext cx="9906120" cy="4212720"/>
            <a:chOff x="0" y="2106720"/>
            <a:chExt cx="9906120" cy="4212720"/>
          </a:xfrm>
        </p:grpSpPr>
        <p:sp>
          <p:nvSpPr>
            <p:cNvPr id="43" name="TextBox 40"/>
            <p:cNvSpPr/>
            <p:nvPr/>
          </p:nvSpPr>
          <p:spPr>
            <a:xfrm>
              <a:off x="0" y="3133800"/>
              <a:ext cx="9906120" cy="28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90000"/>
                </a:lnSpc>
                <a:spcBef>
                  <a:spcPts val="100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UPPLEMENTAL FIGURE 1.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Picture 133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8080560" y="240588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133" descr=""/>
            <p:cNvPicPr/>
            <p:nvPr/>
          </p:nvPicPr>
          <p:blipFill>
            <a:blip r:embed="rId2">
              <a:grayscl/>
            </a:blip>
            <a:stretch/>
          </p:blipFill>
          <p:spPr>
            <a:xfrm>
              <a:off x="8080560" y="3630600"/>
              <a:ext cx="158580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133" descr=""/>
            <p:cNvPicPr/>
            <p:nvPr/>
          </p:nvPicPr>
          <p:blipFill>
            <a:blip r:embed="rId3">
              <a:grayscl/>
            </a:blip>
            <a:stretch/>
          </p:blipFill>
          <p:spPr>
            <a:xfrm>
              <a:off x="8080560" y="4855320"/>
              <a:ext cx="1585800" cy="118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26"/>
            <p:cNvSpPr/>
            <p:nvPr/>
          </p:nvSpPr>
          <p:spPr>
            <a:xfrm rot="16200000">
              <a:off x="9152640" y="5307480"/>
              <a:ext cx="118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% BS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26"/>
            <p:cNvSpPr/>
            <p:nvPr/>
          </p:nvSpPr>
          <p:spPr>
            <a:xfrm rot="16200000">
              <a:off x="9150480" y="4086720"/>
              <a:ext cx="118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% FB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26"/>
            <p:cNvSpPr/>
            <p:nvPr/>
          </p:nvSpPr>
          <p:spPr>
            <a:xfrm rot="16200000">
              <a:off x="9150480" y="2862000"/>
              <a:ext cx="118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% FB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0" name="Picture 130" descr=""/>
            <p:cNvPicPr/>
            <p:nvPr/>
          </p:nvPicPr>
          <p:blipFill>
            <a:blip r:embed="rId4">
              <a:grayscl/>
            </a:blip>
            <a:stretch/>
          </p:blipFill>
          <p:spPr>
            <a:xfrm>
              <a:off x="1643040" y="240804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30" descr=""/>
            <p:cNvPicPr/>
            <p:nvPr/>
          </p:nvPicPr>
          <p:blipFill>
            <a:blip r:embed="rId5">
              <a:grayscl/>
            </a:blip>
            <a:stretch/>
          </p:blipFill>
          <p:spPr>
            <a:xfrm>
              <a:off x="1643760" y="3630600"/>
              <a:ext cx="158580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30" descr=""/>
            <p:cNvPicPr/>
            <p:nvPr/>
          </p:nvPicPr>
          <p:blipFill>
            <a:blip r:embed="rId6">
              <a:grayscl/>
            </a:blip>
            <a:stretch/>
          </p:blipFill>
          <p:spPr>
            <a:xfrm>
              <a:off x="1643040" y="485532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30" descr=""/>
            <p:cNvPicPr/>
            <p:nvPr/>
          </p:nvPicPr>
          <p:blipFill>
            <a:blip r:embed="rId7">
              <a:grayscl/>
            </a:blip>
            <a:stretch/>
          </p:blipFill>
          <p:spPr>
            <a:xfrm>
              <a:off x="45000" y="2405880"/>
              <a:ext cx="158580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30" descr=""/>
            <p:cNvPicPr/>
            <p:nvPr/>
          </p:nvPicPr>
          <p:blipFill>
            <a:blip r:embed="rId8">
              <a:grayscl/>
            </a:blip>
            <a:stretch/>
          </p:blipFill>
          <p:spPr>
            <a:xfrm>
              <a:off x="44280" y="363348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130" descr=""/>
            <p:cNvPicPr/>
            <p:nvPr/>
          </p:nvPicPr>
          <p:blipFill>
            <a:blip r:embed="rId9">
              <a:grayscl/>
            </a:blip>
            <a:stretch/>
          </p:blipFill>
          <p:spPr>
            <a:xfrm>
              <a:off x="42840" y="485424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23"/>
            <p:cNvSpPr/>
            <p:nvPr/>
          </p:nvSpPr>
          <p:spPr>
            <a:xfrm>
              <a:off x="47520" y="6042960"/>
              <a:ext cx="158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 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23"/>
            <p:cNvSpPr/>
            <p:nvPr/>
          </p:nvSpPr>
          <p:spPr>
            <a:xfrm>
              <a:off x="1636560" y="6042960"/>
              <a:ext cx="159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 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3"/>
            <p:cNvSpPr/>
            <p:nvPr/>
          </p:nvSpPr>
          <p:spPr>
            <a:xfrm>
              <a:off x="42840" y="2106720"/>
              <a:ext cx="318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9" name="Picture 132" descr=""/>
            <p:cNvPicPr/>
            <p:nvPr/>
          </p:nvPicPr>
          <p:blipFill>
            <a:blip r:embed="rId10">
              <a:grayscl/>
            </a:blip>
            <a:stretch/>
          </p:blipFill>
          <p:spPr>
            <a:xfrm>
              <a:off x="4862520" y="2408760"/>
              <a:ext cx="1587240" cy="118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132" descr=""/>
            <p:cNvPicPr/>
            <p:nvPr/>
          </p:nvPicPr>
          <p:blipFill>
            <a:blip r:embed="rId11">
              <a:grayscl/>
            </a:blip>
            <a:stretch/>
          </p:blipFill>
          <p:spPr>
            <a:xfrm>
              <a:off x="4864320" y="3630600"/>
              <a:ext cx="158580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132" descr=""/>
            <p:cNvPicPr/>
            <p:nvPr/>
          </p:nvPicPr>
          <p:blipFill>
            <a:blip r:embed="rId12">
              <a:grayscl/>
            </a:blip>
            <a:stretch/>
          </p:blipFill>
          <p:spPr>
            <a:xfrm>
              <a:off x="4862520" y="485532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132" descr=""/>
            <p:cNvPicPr/>
            <p:nvPr/>
          </p:nvPicPr>
          <p:blipFill>
            <a:blip r:embed="rId13">
              <a:grayscl/>
            </a:blip>
            <a:stretch/>
          </p:blipFill>
          <p:spPr>
            <a:xfrm>
              <a:off x="3267000" y="2408760"/>
              <a:ext cx="158580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132" descr=""/>
            <p:cNvPicPr/>
            <p:nvPr/>
          </p:nvPicPr>
          <p:blipFill>
            <a:blip r:embed="rId14">
              <a:grayscl/>
            </a:blip>
            <a:stretch/>
          </p:blipFill>
          <p:spPr>
            <a:xfrm>
              <a:off x="3264840" y="3632040"/>
              <a:ext cx="1587240" cy="118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132" descr=""/>
            <p:cNvPicPr/>
            <p:nvPr/>
          </p:nvPicPr>
          <p:blipFill>
            <a:blip r:embed="rId15">
              <a:grayscl/>
            </a:blip>
            <a:stretch/>
          </p:blipFill>
          <p:spPr>
            <a:xfrm>
              <a:off x="3266280" y="485532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TextBox 25"/>
            <p:cNvSpPr/>
            <p:nvPr/>
          </p:nvSpPr>
          <p:spPr>
            <a:xfrm>
              <a:off x="3263040" y="2108880"/>
              <a:ext cx="318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otenone (5 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6" name="Picture 133" descr=""/>
            <p:cNvPicPr/>
            <p:nvPr/>
          </p:nvPicPr>
          <p:blipFill>
            <a:blip r:embed="rId16">
              <a:grayscl/>
            </a:blip>
            <a:stretch/>
          </p:blipFill>
          <p:spPr>
            <a:xfrm>
              <a:off x="6485040" y="2405880"/>
              <a:ext cx="1587240" cy="11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133" descr=""/>
            <p:cNvPicPr/>
            <p:nvPr/>
          </p:nvPicPr>
          <p:blipFill>
            <a:blip r:embed="rId17">
              <a:grayscl/>
            </a:blip>
            <a:stretch/>
          </p:blipFill>
          <p:spPr>
            <a:xfrm>
              <a:off x="6485040" y="3632040"/>
              <a:ext cx="1585800" cy="118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133" descr=""/>
            <p:cNvPicPr/>
            <p:nvPr/>
          </p:nvPicPr>
          <p:blipFill>
            <a:blip r:embed="rId18">
              <a:grayscl/>
            </a:blip>
            <a:stretch/>
          </p:blipFill>
          <p:spPr>
            <a:xfrm>
              <a:off x="6481800" y="4855320"/>
              <a:ext cx="1585800" cy="118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Box 26"/>
            <p:cNvSpPr/>
            <p:nvPr/>
          </p:nvSpPr>
          <p:spPr>
            <a:xfrm>
              <a:off x="6475320" y="2110320"/>
              <a:ext cx="319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otenone (10 </a:t>
              </a: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23"/>
            <p:cNvSpPr/>
            <p:nvPr/>
          </p:nvSpPr>
          <p:spPr>
            <a:xfrm>
              <a:off x="3263040" y="6038280"/>
              <a:ext cx="158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 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23"/>
            <p:cNvSpPr/>
            <p:nvPr/>
          </p:nvSpPr>
          <p:spPr>
            <a:xfrm>
              <a:off x="4852080" y="6038280"/>
              <a:ext cx="159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 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23"/>
            <p:cNvSpPr/>
            <p:nvPr/>
          </p:nvSpPr>
          <p:spPr>
            <a:xfrm>
              <a:off x="6475320" y="6028200"/>
              <a:ext cx="158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 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23"/>
            <p:cNvSpPr/>
            <p:nvPr/>
          </p:nvSpPr>
          <p:spPr>
            <a:xfrm>
              <a:off x="8064360" y="6028200"/>
              <a:ext cx="159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 h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1-28T01:43:29Z</dcterms:created>
  <dc:creator>melanimahesh@dgist.ac.kr</dc:creator>
  <dc:description/>
  <dc:language>en-US</dc:language>
  <cp:lastModifiedBy>mahesh</cp:lastModifiedBy>
  <dcterms:modified xsi:type="dcterms:W3CDTF">2019-07-21T14:01:41Z</dcterms:modified>
  <cp:revision>849</cp:revision>
  <dc:subject/>
  <dc:title>PowerPoint Presentation</dc:title>
</cp:coreProperties>
</file>